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60" r:id="rId1"/>
  </p:sldMasterIdLst>
  <p:notesMasterIdLst>
    <p:notesMasterId r:id="rId27"/>
  </p:notesMasterIdLst>
  <p:sldIdLst>
    <p:sldId id="281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9E391A7-F93A-445C-889E-C0AA8E0B21B8}" v="145" dt="2021-03-11T16:04:44.2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533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168" y="1000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5/10/relationships/revisionInfo" Target="revisionInfo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notesMaster" Target="notesMasters/notesMaster1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42982885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4dd1b48b88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4dd1b48b88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4b1ba7b1d0_1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4b1ba7b1d0_1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g4b1ba7b1d0_1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4" name="Google Shape;124;g4b1ba7b1d0_1_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g4dd776810c_0_5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0" name="Google Shape;130;g4dd776810c_0_5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g4dd776810c_0_6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6" name="Google Shape;136;g4dd776810c_0_6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g4dd776810c_0_7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2" name="Google Shape;142;g4dd776810c_0_7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g4dd776810c_0_5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8" name="Google Shape;148;g4dd776810c_0_5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900" dirty="0">
              <a:solidFill>
                <a:schemeClr val="dk1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g4e7afa6338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4" name="Google Shape;154;g4e7afa6338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850" dirty="0">
              <a:solidFill>
                <a:schemeClr val="dk1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g4e7afa6338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0" name="Google Shape;160;g4e7afa6338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850" dirty="0">
              <a:solidFill>
                <a:schemeClr val="dk1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g4e7afa6338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6" name="Google Shape;166;g4e7afa6338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 dirty="0">
              <a:solidFill>
                <a:schemeClr val="dk1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g4e7afa6338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2" name="Google Shape;172;g4e7afa6338_0_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850" dirty="0">
              <a:solidFill>
                <a:schemeClr val="dk1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4dd1b48b88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4dd1b48b88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urhan MD, et al. </a:t>
            </a:r>
            <a:r>
              <a:rPr lang="en" b="1">
                <a:solidFill>
                  <a:schemeClr val="dk1"/>
                </a:solidFill>
                <a:highlight>
                  <a:srgbClr val="FFFFFF"/>
                </a:highlight>
              </a:rPr>
              <a:t>Diagnosis and acute management of suspected nephrolithiasis in adults. Post TW, ed.  Waltham, MA: </a:t>
            </a:r>
            <a:r>
              <a:rPr lang="en" sz="1200">
                <a:solidFill>
                  <a:srgbClr val="474747"/>
                </a:solidFill>
                <a:highlight>
                  <a:srgbClr val="FFFFFF"/>
                </a:highlight>
              </a:rPr>
              <a:t>UpToDate Inc. </a:t>
            </a:r>
            <a:r>
              <a:rPr lang="en" sz="1200" u="sng">
                <a:solidFill>
                  <a:srgbClr val="007AC3"/>
                </a:solidFill>
                <a:highlight>
                  <a:srgbClr val="FFFFFF"/>
                </a:highlight>
                <a:hlinkClick r:id="rId3"/>
              </a:rPr>
              <a:t>https://www.uptodate.com</a:t>
            </a:r>
            <a:r>
              <a:rPr lang="en" sz="1200">
                <a:solidFill>
                  <a:srgbClr val="474747"/>
                </a:solidFill>
                <a:highlight>
                  <a:srgbClr val="FFFFFF"/>
                </a:highlight>
              </a:rPr>
              <a:t> (Accessed on January 27, 2019.)</a:t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g4e7afa6338_0_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8" name="Google Shape;178;g4e7afa6338_0_3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 dirty="0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g4e7afa6338_0_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84" name="Google Shape;184;g4e7afa6338_0_4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dirty="0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g4dd776810c_0_6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0" name="Google Shape;190;g4dd776810c_0_6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5588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g4b1ba7b1d0_1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6" name="Google Shape;196;g4b1ba7b1d0_1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g4b1ba7b1d0_1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02" name="Google Shape;202;g4b1ba7b1d0_1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00" dirty="0">
              <a:solidFill>
                <a:srgbClr val="666666"/>
              </a:solidFill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4dd1b48b88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4dd1b48b88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4dd776810c_0_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4dd776810c_0_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4dd776810c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4dd776810c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g4dd776810c_0_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0" name="Google Shape;90;g4dd776810c_0_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lvl="0" indent="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Verdana"/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g4dd776810c_0_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7" name="Google Shape;97;g4dd776810c_0_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lvl="0" indent="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Verdana"/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g4dd776810c_0_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4" name="Google Shape;104;g4dd776810c_0_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4dd776810c_0_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1" name="Google Shape;111;g4dd776810c_0_3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9321842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43994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3049720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206691984"/>
      </p:ext>
    </p:extLst>
  </p:cSld>
  <p:clrMapOvr>
    <a:masterClrMapping/>
  </p:clrMapOvr>
  <p:hf sldNum="0" hdr="0" ft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9260875"/>
      </p:ext>
    </p:extLst>
  </p:cSld>
  <p:clrMapOvr>
    <a:masterClrMapping/>
  </p:clrMapOvr>
  <p:hf sldNum="0" hdr="0" ft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 slid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4128012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52453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2936380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825272337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1982636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4127578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3698602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4597891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809286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252750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027815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hf sldNum="0"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5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5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5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5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5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5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5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15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5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15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diagnosis-and-acute-management-of-suspected-nephrolithiasis-in-adults" TargetMode="External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15.xml"/><Relationship Id="rId4" Type="http://schemas.openxmlformats.org/officeDocument/2006/relationships/hyperlink" Target="https://radiopaedia.org/articles/ureteric-calculi?lang=us" TargetMode="Externa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F04D0E-8DF3-43D3-A949-6266194D4F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19818" y="1856183"/>
            <a:ext cx="5943600" cy="1859909"/>
          </a:xfrm>
        </p:spPr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Arial"/>
              </a:rPr>
              <a:t>Nephrolithiasis</a:t>
            </a:r>
            <a:r>
              <a:rPr lang="en-US" b="0" i="0" dirty="0">
                <a:latin typeface="Arial"/>
              </a:rPr>
              <a:t>​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B9065D-6BA2-440B-8988-614ED1BB7C1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7FD3171-78A2-684E-96E6-14917E6C6C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3538" y="4572703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79621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Google Shape;113;p2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114" name="Google Shape;114;p22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MRI Abdomen and Pelvis</a:t>
            </a:r>
            <a:endParaRPr b="1"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No ionizing radiation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Reliably detects hydronephrosi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Accurately localizes the site of ureteral obstruction for treatment planning</a:t>
            </a:r>
            <a:endParaRPr dirty="0"/>
          </a:p>
          <a:p>
            <a:pPr marL="1371600" lvl="2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■"/>
            </a:pPr>
            <a:r>
              <a:rPr lang="en" dirty="0"/>
              <a:t>Typical use is in pregnant women with hydronephrosis seen on U/S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Dis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Very low sensitivity because stones are nearly invisible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Inaccurate stone size measurements for treatment planning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Requires patient lie still in enclosed scanner for 10-20 minutes</a:t>
            </a:r>
            <a:endParaRPr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23"/>
          <p:cNvSpPr txBox="1">
            <a:spLocks noGrp="1"/>
          </p:cNvSpPr>
          <p:nvPr>
            <p:ph type="title"/>
          </p:nvPr>
        </p:nvSpPr>
        <p:spPr>
          <a:xfrm>
            <a:off x="311700" y="3688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mplications of Nephrolithiasis</a:t>
            </a:r>
            <a:endParaRPr/>
          </a:p>
        </p:txBody>
      </p:sp>
      <p:sp>
        <p:nvSpPr>
          <p:cNvPr id="121" name="Google Shape;121;p23"/>
          <p:cNvSpPr txBox="1">
            <a:spLocks noGrp="1"/>
          </p:cNvSpPr>
          <p:nvPr>
            <p:ph type="body" idx="1"/>
          </p:nvPr>
        </p:nvSpPr>
        <p:spPr>
          <a:xfrm>
            <a:off x="311700" y="923875"/>
            <a:ext cx="8520600" cy="3990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Urosepsis due to Obstructive Uropathy (requires </a:t>
            </a:r>
            <a:r>
              <a:rPr lang="en" b="1" u="sng" dirty="0"/>
              <a:t>urgent decompression</a:t>
            </a:r>
            <a:r>
              <a:rPr lang="en" b="1" dirty="0"/>
              <a:t> and </a:t>
            </a:r>
            <a:r>
              <a:rPr lang="en" b="1" u="sng" dirty="0"/>
              <a:t>broad spectrum antibiotics</a:t>
            </a:r>
            <a:r>
              <a:rPr lang="en" b="1" dirty="0"/>
              <a:t>)</a:t>
            </a:r>
            <a:endParaRPr b="1" dirty="0"/>
          </a:p>
          <a:p>
            <a:pPr marL="457200" lvl="0" indent="-330200" algn="l" rtl="0">
              <a:spcBef>
                <a:spcPts val="1600"/>
              </a:spcBef>
              <a:spcAft>
                <a:spcPts val="0"/>
              </a:spcAft>
              <a:buSzPts val="1600"/>
              <a:buChar char="●"/>
            </a:pPr>
            <a:r>
              <a:rPr lang="en" sz="1600" dirty="0"/>
              <a:t>Vitals</a:t>
            </a:r>
            <a:endParaRPr sz="16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Monitor for fevers, hemodynamic instability, and/or tachypnea</a:t>
            </a:r>
            <a:endParaRPr dirty="0"/>
          </a:p>
          <a:p>
            <a:pPr marL="457200" lvl="0" indent="-330200" algn="l" rtl="0">
              <a:spcBef>
                <a:spcPts val="0"/>
              </a:spcBef>
              <a:spcAft>
                <a:spcPts val="0"/>
              </a:spcAft>
              <a:buSzPts val="1600"/>
              <a:buChar char="●"/>
            </a:pPr>
            <a:r>
              <a:rPr lang="en" sz="1600" dirty="0"/>
              <a:t>Exam</a:t>
            </a:r>
            <a:endParaRPr sz="16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Toxic </a:t>
            </a:r>
            <a:r>
              <a:rPr lang="en" dirty="0">
                <a:solidFill>
                  <a:schemeClr val="bg1"/>
                </a:solidFill>
              </a:rPr>
              <a:t>appearing</a:t>
            </a:r>
            <a:endParaRPr dirty="0">
              <a:solidFill>
                <a:schemeClr val="bg1"/>
              </a:solidFill>
            </a:endParaRPr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>
                <a:solidFill>
                  <a:schemeClr val="bg1"/>
                </a:solidFill>
              </a:rPr>
              <a:t>Costovertebral angle tenderness</a:t>
            </a:r>
            <a:r>
              <a:rPr lang="en" dirty="0"/>
              <a:t>, suprapubic pain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Warm extremities</a:t>
            </a:r>
            <a:endParaRPr dirty="0"/>
          </a:p>
          <a:p>
            <a:pPr marL="457200" lvl="0" indent="-330200" algn="l" rtl="0">
              <a:spcBef>
                <a:spcPts val="0"/>
              </a:spcBef>
              <a:spcAft>
                <a:spcPts val="0"/>
              </a:spcAft>
              <a:buSzPts val="1600"/>
              <a:buChar char="●"/>
            </a:pPr>
            <a:r>
              <a:rPr lang="en" sz="1600" dirty="0"/>
              <a:t>Labs</a:t>
            </a:r>
            <a:endParaRPr sz="16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Leukocytosis (look for neutrophil predominance and/or bands)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Urinalysis with presence of WBC, leukocyte esterase, bacteria, nitrite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Elevated lactate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Decreased serum bicarbonate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Positive blood cultures, urine cultures</a:t>
            </a:r>
            <a:endParaRPr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2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mplications of Nephrolithiasis</a:t>
            </a:r>
            <a:endParaRPr/>
          </a:p>
        </p:txBody>
      </p:sp>
      <p:sp>
        <p:nvSpPr>
          <p:cNvPr id="127" name="Google Shape;127;p24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Acute Kidney Injury (requires </a:t>
            </a:r>
            <a:r>
              <a:rPr lang="en" b="1" u="sng"/>
              <a:t>urgent decompression</a:t>
            </a:r>
            <a:r>
              <a:rPr lang="en" b="1"/>
              <a:t>)</a:t>
            </a:r>
            <a:endParaRPr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Bilateral ureteral obstruction or unilateral obstruction in a solitary kidney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Elevated serum creatinine, oliguria or anuria</a:t>
            </a:r>
            <a:endParaRPr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25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33" name="Google Shape;133;p25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Patients can be managed at </a:t>
            </a:r>
            <a:r>
              <a:rPr lang="en" b="1"/>
              <a:t>home </a:t>
            </a:r>
            <a:r>
              <a:rPr lang="en"/>
              <a:t>if they are able to tolerate </a:t>
            </a:r>
            <a:r>
              <a:rPr lang="en" b="1"/>
              <a:t>oral hydration and pain medications.</a:t>
            </a:r>
            <a:endParaRPr b="1"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r>
              <a:rPr lang="en"/>
              <a:t>Patients should be </a:t>
            </a:r>
            <a:r>
              <a:rPr lang="en" b="1"/>
              <a:t>hospitalized </a:t>
            </a:r>
            <a:r>
              <a:rPr lang="en"/>
              <a:t>if they </a:t>
            </a:r>
            <a:r>
              <a:rPr lang="en" b="1"/>
              <a:t>cannot tolerate oral intake</a:t>
            </a:r>
            <a:r>
              <a:rPr lang="en"/>
              <a:t> or have </a:t>
            </a:r>
            <a:r>
              <a:rPr lang="en" b="1"/>
              <a:t>uncontrolled pain</a:t>
            </a:r>
            <a:r>
              <a:rPr lang="en"/>
              <a:t> or </a:t>
            </a:r>
            <a:r>
              <a:rPr lang="en" b="1"/>
              <a:t>fever</a:t>
            </a:r>
            <a:r>
              <a:rPr lang="en"/>
              <a:t>.</a:t>
            </a: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2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39" name="Google Shape;139;p2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b="1" dirty="0"/>
              <a:t>Straining Urine</a:t>
            </a:r>
            <a:endParaRPr b="1" dirty="0"/>
          </a:p>
          <a:p>
            <a:pPr marL="45720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 dirty="0"/>
              <a:t>Analgesics</a:t>
            </a:r>
            <a:endParaRPr b="1" dirty="0"/>
          </a:p>
          <a:p>
            <a:pPr marL="45720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 dirty="0"/>
              <a:t>Hydration</a:t>
            </a:r>
            <a:endParaRPr b="1" dirty="0"/>
          </a:p>
          <a:p>
            <a:pPr marL="45720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 dirty="0"/>
              <a:t>Stone Passage</a:t>
            </a:r>
            <a:endParaRPr b="1" dirty="0"/>
          </a:p>
          <a:p>
            <a:pPr marL="45720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r>
              <a:rPr lang="en" b="1" dirty="0"/>
              <a:t>Urologic Consultation</a:t>
            </a:r>
            <a:endParaRPr b="1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2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45" name="Google Shape;145;p27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Straining Urine</a:t>
            </a:r>
            <a:endParaRPr b="1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/>
              <a:t>Patients should:</a:t>
            </a:r>
            <a:endParaRPr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Strain urine for several day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Bring in any stone that passes for analysi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Helps plan preventive therapy</a:t>
            </a:r>
            <a:endParaRPr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28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51" name="Google Shape;151;p28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Analgesics - NSAIDs vs. Opioids</a:t>
            </a:r>
            <a:endParaRPr b="1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dirty="0"/>
              <a:t>NSAIDs</a:t>
            </a:r>
            <a:endParaRPr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Possibly decreases ureteral smooth muscle tone, thereby directly treating the mechanism by which pain is thought to occur (ureteral spasm)</a:t>
            </a:r>
            <a:r>
              <a:rPr lang="en" baseline="30000" dirty="0"/>
              <a:t>7</a:t>
            </a:r>
            <a:endParaRPr baseline="300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Lower requirement for rescue analgesia</a:t>
            </a:r>
            <a:r>
              <a:rPr lang="en" baseline="30000" dirty="0"/>
              <a:t>8</a:t>
            </a:r>
            <a:endParaRPr baseline="300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Lower incidence of adverse side effects (nausea/vomiting)</a:t>
            </a:r>
            <a:r>
              <a:rPr lang="en" baseline="30000" dirty="0"/>
              <a:t>8</a:t>
            </a:r>
            <a:endParaRPr baseline="30000"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Dis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In patients with preexisting renal disease or severe volume depletion, NSAIDs may interfere with the kidney’s autoregulatory response to acute obstruction and induce acute kidney injury (AKI)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NSAIDs must be stopped 3 days prior to anticipated </a:t>
            </a:r>
            <a:r>
              <a:rPr lang="en-US" dirty="0"/>
              <a:t>shockwave lithotripsy (</a:t>
            </a:r>
            <a:r>
              <a:rPr lang="en" dirty="0"/>
              <a:t>SWL) to minimize risk of bleeding</a:t>
            </a: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29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57" name="Google Shape;157;p29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Analgesics - NSAIDs vs. Opioids</a:t>
            </a:r>
            <a:endParaRPr b="1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/>
              <a:t>Opioids</a:t>
            </a:r>
            <a:endParaRPr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Titratable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Potent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Dis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Concern for dependency and drug seeking behavior presenting as renal colic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Do not act directly on the cause of pain, which may limit its usefulness</a:t>
            </a:r>
            <a:endParaRPr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30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63" name="Google Shape;163;p30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1981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Analgesics - NSAIDs vs. Opioids</a:t>
            </a:r>
            <a:endParaRPr b="1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600" dirty="0"/>
              <a:t>Clinical Evidence</a:t>
            </a:r>
            <a:endParaRPr sz="1600" dirty="0"/>
          </a:p>
          <a:p>
            <a:pPr marL="457200" lvl="0" indent="-317500" algn="l" rtl="0">
              <a:spcBef>
                <a:spcPts val="1600"/>
              </a:spcBef>
              <a:spcAft>
                <a:spcPts val="0"/>
              </a:spcAft>
              <a:buSzPts val="1400"/>
              <a:buChar char="●"/>
            </a:pPr>
            <a:r>
              <a:rPr lang="en" sz="1400" b="1" dirty="0"/>
              <a:t>“Systematic review of the relative efficacy of non-steroidal anti-inflammatory drugs and opioids in the treatment of acute renal colic”</a:t>
            </a:r>
            <a:endParaRPr sz="1400" b="1" dirty="0"/>
          </a:p>
          <a:p>
            <a:pPr marL="914400" lvl="1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i="1" dirty="0"/>
              <a:t>BMJ</a:t>
            </a:r>
            <a:r>
              <a:rPr lang="en" sz="1200" dirty="0"/>
              <a:t> 2004 June 12;328(7453): 1401</a:t>
            </a:r>
            <a:endParaRPr sz="1200" dirty="0"/>
          </a:p>
          <a:p>
            <a:pPr marL="914400" lvl="1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Reviewed </a:t>
            </a:r>
            <a:r>
              <a:rPr lang="en" sz="1200" b="1" dirty="0"/>
              <a:t>20 trials</a:t>
            </a:r>
            <a:r>
              <a:rPr lang="en" sz="1200" dirty="0"/>
              <a:t> totaling </a:t>
            </a:r>
            <a:r>
              <a:rPr lang="en" sz="1200" b="1" dirty="0"/>
              <a:t>1613 patients</a:t>
            </a:r>
            <a:endParaRPr sz="1200" b="1" dirty="0"/>
          </a:p>
          <a:p>
            <a:pPr marL="914400" lvl="1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Pooled analysis of 6 trials showed patients treated with </a:t>
            </a:r>
            <a:r>
              <a:rPr lang="en" sz="1200" b="1" dirty="0"/>
              <a:t>NSAIDs showed greater reduction in pain scores than those treated with opioids</a:t>
            </a:r>
            <a:endParaRPr sz="1200" b="1" dirty="0"/>
          </a:p>
          <a:p>
            <a:pPr marL="914400" lvl="1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Patients treated with </a:t>
            </a:r>
            <a:r>
              <a:rPr lang="en" sz="1200" b="1" dirty="0"/>
              <a:t>NSAIDs were significantly less likely to require rescue analgesia</a:t>
            </a:r>
            <a:r>
              <a:rPr lang="en" sz="1200" dirty="0"/>
              <a:t> (RR 0.75, 95% CI 0.61-0.93)</a:t>
            </a:r>
            <a:endParaRPr sz="1200" dirty="0"/>
          </a:p>
          <a:p>
            <a:pPr marL="914400" lvl="1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Most trials showed </a:t>
            </a:r>
            <a:r>
              <a:rPr lang="en" sz="1200" b="1" dirty="0"/>
              <a:t>higher incidence of adverse events in patients treated with opioids</a:t>
            </a:r>
            <a:endParaRPr sz="1200" b="1" dirty="0"/>
          </a:p>
          <a:p>
            <a:pPr marL="1371600" lvl="2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b="1" dirty="0"/>
              <a:t>NSAIDs caused less vomiting than opioids</a:t>
            </a:r>
            <a:r>
              <a:rPr lang="en" sz="1200" dirty="0"/>
              <a:t> (0.35, 95% CI 0.23-0.53)</a:t>
            </a:r>
            <a:endParaRPr sz="1200" dirty="0"/>
          </a:p>
          <a:p>
            <a:pPr marL="1371600" lvl="2" indent="-304800" algn="l" rtl="0"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dirty="0"/>
              <a:t>No trials reports increased risk of GI bleeding with NSAIDs (but typically short term follow up ~24 hours)</a:t>
            </a:r>
            <a:endParaRPr sz="1200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3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69" name="Google Shape;169;p3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673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Analgesics - NSAIDs vs. Opioids</a:t>
            </a:r>
            <a:endParaRPr b="1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600" dirty="0"/>
              <a:t>Clinical Evidence</a:t>
            </a:r>
            <a:endParaRPr sz="1600" dirty="0"/>
          </a:p>
          <a:p>
            <a:pPr marL="457200" marR="0" lvl="0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Char char="●"/>
            </a:pPr>
            <a:r>
              <a:rPr lang="en" sz="1200" b="1" dirty="0"/>
              <a:t>“Intravenous morphine plus ketorolac is superior to either drug alone for treatment of acute renal colic”</a:t>
            </a:r>
            <a:endParaRPr sz="1200" b="1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i="1" dirty="0"/>
              <a:t>Ann Emerg Med</a:t>
            </a:r>
            <a:r>
              <a:rPr lang="en" sz="1200" dirty="0"/>
              <a:t>. 2006 Aug;48(2):173-81, 181e1.</a:t>
            </a:r>
            <a:endParaRPr sz="1200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Prospective, double-blinded, RCT at Yale University, New Haven, CT</a:t>
            </a:r>
            <a:endParaRPr sz="1200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N+ 130, patients aged 18-55 y/o</a:t>
            </a:r>
            <a:endParaRPr sz="1200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Treatment arms</a:t>
            </a:r>
            <a:endParaRPr sz="1200" dirty="0"/>
          </a:p>
          <a:p>
            <a:pPr marL="1371600" marR="0" lvl="2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000"/>
              <a:buChar char="■"/>
            </a:pPr>
            <a:r>
              <a:rPr lang="en" sz="1000" dirty="0"/>
              <a:t>Morphine IV 5 mg at time zero and 5 mg at 20 minutes</a:t>
            </a:r>
            <a:endParaRPr sz="1000" dirty="0"/>
          </a:p>
          <a:p>
            <a:pPr marL="1371600" marR="0" lvl="2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000"/>
              <a:buChar char="■"/>
            </a:pPr>
            <a:r>
              <a:rPr lang="en" sz="1000" dirty="0"/>
              <a:t>Ketorolac IV 15 mg at time zero and 15 mg at 20 minutes</a:t>
            </a:r>
            <a:endParaRPr sz="1000" dirty="0"/>
          </a:p>
          <a:p>
            <a:pPr marL="1371600" marR="0" lvl="2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000"/>
              <a:buChar char="■"/>
            </a:pPr>
            <a:r>
              <a:rPr lang="en" sz="1000" dirty="0"/>
              <a:t>Combination of both</a:t>
            </a:r>
            <a:endParaRPr sz="1000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Primary outcomes</a:t>
            </a:r>
            <a:endParaRPr sz="1200" dirty="0"/>
          </a:p>
          <a:p>
            <a:pPr marL="1371600" marR="0" lvl="2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000"/>
              <a:buChar char="■"/>
            </a:pPr>
            <a:r>
              <a:rPr lang="en" sz="1000" dirty="0"/>
              <a:t>Pain reduction</a:t>
            </a:r>
            <a:endParaRPr sz="1000" dirty="0"/>
          </a:p>
          <a:p>
            <a:pPr marL="1371600" marR="0" lvl="2" indent="-2921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000"/>
              <a:buChar char="■"/>
            </a:pPr>
            <a:r>
              <a:rPr lang="en" sz="1000" dirty="0"/>
              <a:t>Need for rescue analgesia at 40 minutes</a:t>
            </a:r>
            <a:endParaRPr sz="1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Objectives</a:t>
            </a:r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By the end of this lecture, learners will understand:</a:t>
            </a:r>
            <a:endParaRPr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/>
              <a:t>Diagnostic modalities to evaluate renal colic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/>
              <a:t>What lab tests are indicated when evaluating potential complications of stone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/>
              <a:t>Evidence supporting different analgesic agent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/>
              <a:t>When an urgent procedural intervention is indicated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/>
              <a:t>When it is appropriate to disposition the patient</a:t>
            </a:r>
            <a:endParaRPr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3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75" name="Google Shape;175;p32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3142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Analgesics - NSAIDs vs. Opioids</a:t>
            </a:r>
            <a:endParaRPr b="1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600" dirty="0"/>
              <a:t>Clinical Evidence</a:t>
            </a:r>
            <a:endParaRPr sz="1600" dirty="0"/>
          </a:p>
          <a:p>
            <a:pPr marL="457200" marR="0" lvl="0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</a:pPr>
            <a:r>
              <a:rPr lang="en" sz="1400" b="1" dirty="0"/>
              <a:t>“Intravenous morphine plus ketorolac is superior to either drug alone for treatment of acute renal colic”</a:t>
            </a:r>
            <a:endParaRPr sz="1400" b="1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○"/>
            </a:pPr>
            <a:r>
              <a:rPr lang="en" sz="1200" dirty="0"/>
              <a:t>Mean difference in change in pain score (visual analog scale at 40 minutes minus at time zero)</a:t>
            </a:r>
            <a:endParaRPr sz="1200" dirty="0"/>
          </a:p>
          <a:p>
            <a:pPr marL="1371600" marR="0" lvl="2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■"/>
            </a:pPr>
            <a:r>
              <a:rPr lang="en" sz="1200" b="1" dirty="0"/>
              <a:t>Combination </a:t>
            </a:r>
            <a:r>
              <a:rPr lang="en" sz="1200" dirty="0"/>
              <a:t>group vs. </a:t>
            </a:r>
            <a:r>
              <a:rPr lang="en" sz="1200" b="1" dirty="0"/>
              <a:t>morphine </a:t>
            </a:r>
            <a:r>
              <a:rPr lang="en" sz="1200" dirty="0"/>
              <a:t>group difference was</a:t>
            </a:r>
            <a:r>
              <a:rPr lang="en" sz="1200" b="1" dirty="0"/>
              <a:t> -1.8 cm (95% CI -3.3 to -0.1, p&lt;0.003)</a:t>
            </a:r>
            <a:endParaRPr sz="1200" b="1" dirty="0"/>
          </a:p>
          <a:p>
            <a:pPr marL="1371600" marR="0" lvl="2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b="1" dirty="0"/>
              <a:t>Combination </a:t>
            </a:r>
            <a:r>
              <a:rPr lang="en" sz="1200" dirty="0"/>
              <a:t>group vs. </a:t>
            </a:r>
            <a:r>
              <a:rPr lang="en" sz="1200" b="1" dirty="0"/>
              <a:t>ketorolac </a:t>
            </a:r>
            <a:r>
              <a:rPr lang="en" sz="1200" dirty="0"/>
              <a:t>group difference was </a:t>
            </a:r>
            <a:r>
              <a:rPr lang="en" sz="1200" b="1" dirty="0"/>
              <a:t>-2.2 cm (95% CI -3.7 to -0.5, p&lt;0.003)</a:t>
            </a:r>
            <a:endParaRPr sz="1200" b="1" dirty="0"/>
          </a:p>
          <a:p>
            <a:pPr marL="1371600" marR="0" lvl="2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dirty="0"/>
              <a:t>Patients with combination therapy were less likely to require rescue morphine compared to morphine group (OR 0.2, 95% CI 0.1 to 0.7; p=0.007)</a:t>
            </a:r>
            <a:endParaRPr sz="1200" dirty="0"/>
          </a:p>
          <a:p>
            <a:pPr marL="914400" marR="0" lvl="1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</a:pPr>
            <a:r>
              <a:rPr lang="en" sz="1200" dirty="0"/>
              <a:t>Considerations</a:t>
            </a:r>
            <a:endParaRPr sz="1200" dirty="0"/>
          </a:p>
          <a:p>
            <a:pPr marL="1371600" marR="0" lvl="2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dirty="0"/>
              <a:t>Ketorolac IV 15 mg is a relatively low dose (standard dose is 30 mg); may account for these results</a:t>
            </a:r>
            <a:endParaRPr sz="1200" dirty="0"/>
          </a:p>
          <a:p>
            <a:pPr marL="1371600" marR="0" lvl="2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</a:pPr>
            <a:r>
              <a:rPr lang="en" sz="1200" dirty="0"/>
              <a:t>Adverse events not reported (eg, renal failure, GI bleed)</a:t>
            </a:r>
            <a:endParaRPr sz="1200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3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81" name="Google Shape;181;p33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/>
              <a:t>Hydration</a:t>
            </a:r>
            <a:endParaRPr sz="1200" b="1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 dirty="0"/>
              <a:t>“Forced versus minimal intravenous hydration in the management of acute renal colic: a randomized trial”</a:t>
            </a:r>
            <a:r>
              <a:rPr lang="en" dirty="0"/>
              <a:t> </a:t>
            </a:r>
            <a:r>
              <a:rPr lang="en" i="1" dirty="0"/>
              <a:t>J Endourol. </a:t>
            </a:r>
            <a:r>
              <a:rPr lang="en" dirty="0"/>
              <a:t>2006 Oct;20(10):713-6</a:t>
            </a:r>
            <a:endParaRPr dirty="0"/>
          </a:p>
          <a:p>
            <a:pPr marL="457200" lvl="0" indent="-330200" algn="l" rtl="0">
              <a:spcBef>
                <a:spcPts val="1600"/>
              </a:spcBef>
              <a:spcAft>
                <a:spcPts val="0"/>
              </a:spcAft>
              <a:buSzPts val="1600"/>
              <a:buChar char="●"/>
            </a:pPr>
            <a:r>
              <a:rPr lang="en" dirty="0"/>
              <a:t>43 patients (69% men), mean age 41 (range 20-65)</a:t>
            </a:r>
            <a:endParaRPr dirty="0"/>
          </a:p>
          <a:p>
            <a:pPr marL="457200" lvl="0" indent="-330200" algn="l" rtl="0">
              <a:spcBef>
                <a:spcPts val="0"/>
              </a:spcBef>
              <a:spcAft>
                <a:spcPts val="0"/>
              </a:spcAft>
              <a:buSzPts val="1600"/>
              <a:buChar char="●"/>
            </a:pPr>
            <a:r>
              <a:rPr lang="en" dirty="0"/>
              <a:t>Treatment arms: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b="1" dirty="0"/>
              <a:t>Minimal</a:t>
            </a:r>
            <a:r>
              <a:rPr lang="en" sz="1200" dirty="0"/>
              <a:t> IV hydration with NS @ 20 mL/hr (N=23)</a:t>
            </a:r>
            <a:endParaRPr sz="12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b="1" dirty="0"/>
              <a:t>Forced</a:t>
            </a:r>
            <a:r>
              <a:rPr lang="en" sz="1200" dirty="0"/>
              <a:t> IV hydration with 2L NS over 2 hours (N=20)</a:t>
            </a:r>
            <a:endParaRPr sz="1200" dirty="0"/>
          </a:p>
          <a:p>
            <a:pPr marL="457200" lvl="0" indent="-330200" algn="l" rtl="0">
              <a:spcBef>
                <a:spcPts val="0"/>
              </a:spcBef>
              <a:spcAft>
                <a:spcPts val="0"/>
              </a:spcAft>
              <a:buSzPts val="1600"/>
              <a:buChar char="●"/>
            </a:pPr>
            <a:r>
              <a:rPr lang="en" dirty="0"/>
              <a:t>Primary outcomes: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dirty="0"/>
              <a:t>Hourly pain score (visual analog pain scale) for 4 hours - change in score 2.0 vs 2.0 (p=0.629)</a:t>
            </a:r>
            <a:endParaRPr sz="12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dirty="0"/>
              <a:t>Narcotic requirement in morphine equivalents - 15.4 vs 16.4 (p=0.724)</a:t>
            </a:r>
            <a:endParaRPr sz="12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dirty="0"/>
              <a:t>Stone passage rates - 22% vs 30% (p=0.718)</a:t>
            </a:r>
            <a:endParaRPr sz="12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200" dirty="0"/>
              <a:t>Stone size - 3.0 mm vs 3.4 mm (p=0.676)</a:t>
            </a:r>
            <a:endParaRPr sz="1200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34"/>
          <p:cNvSpPr txBox="1">
            <a:spLocks noGrp="1"/>
          </p:cNvSpPr>
          <p:nvPr>
            <p:ph type="title"/>
          </p:nvPr>
        </p:nvSpPr>
        <p:spPr>
          <a:xfrm>
            <a:off x="311700" y="3688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Management</a:t>
            </a:r>
            <a:endParaRPr dirty="0"/>
          </a:p>
        </p:txBody>
      </p:sp>
      <p:sp>
        <p:nvSpPr>
          <p:cNvPr id="187" name="Google Shape;187;p34"/>
          <p:cNvSpPr txBox="1">
            <a:spLocks noGrp="1"/>
          </p:cNvSpPr>
          <p:nvPr>
            <p:ph type="body" idx="1"/>
          </p:nvPr>
        </p:nvSpPr>
        <p:spPr>
          <a:xfrm>
            <a:off x="311700" y="1076275"/>
            <a:ext cx="8520600" cy="3990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Stone Passage</a:t>
            </a:r>
            <a:r>
              <a:rPr lang="en" b="1" baseline="30000" dirty="0"/>
              <a:t>11</a:t>
            </a:r>
            <a:endParaRPr b="1" baseline="30000"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b="1" dirty="0"/>
              <a:t>Stone size</a:t>
            </a:r>
            <a:r>
              <a:rPr lang="en" dirty="0"/>
              <a:t> is the major determinant of likelihood of spontaneous passage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Most st</a:t>
            </a:r>
            <a:r>
              <a:rPr lang="en" dirty="0">
                <a:solidFill>
                  <a:schemeClr val="bg1"/>
                </a:solidFill>
              </a:rPr>
              <a:t>ones</a:t>
            </a:r>
            <a:r>
              <a:rPr lang="en" dirty="0">
                <a:solidFill>
                  <a:srgbClr val="666666"/>
                </a:solidFill>
              </a:rPr>
              <a:t> </a:t>
            </a:r>
            <a:r>
              <a:rPr lang="en" b="1" dirty="0">
                <a:solidFill>
                  <a:srgbClr val="666666"/>
                </a:solidFill>
                <a:highlight>
                  <a:srgbClr val="FFFFFF"/>
                </a:highlight>
              </a:rPr>
              <a:t>≤5mm pass spontaneously</a:t>
            </a:r>
            <a:endParaRPr b="1" dirty="0">
              <a:solidFill>
                <a:srgbClr val="666666"/>
              </a:solidFill>
              <a:highlight>
                <a:srgbClr val="FFFFFF"/>
              </a:highlight>
            </a:endParaRPr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400"/>
              <a:buChar char="○"/>
            </a:pPr>
            <a:r>
              <a:rPr lang="en" dirty="0">
                <a:solidFill>
                  <a:srgbClr val="666666"/>
                </a:solidFill>
                <a:highlight>
                  <a:srgbClr val="FFFFFF"/>
                </a:highlight>
              </a:rPr>
              <a:t>Stones </a:t>
            </a:r>
            <a:r>
              <a:rPr lang="en" b="1" dirty="0">
                <a:solidFill>
                  <a:srgbClr val="666666"/>
                </a:solidFill>
                <a:highlight>
                  <a:srgbClr val="FFFFFF"/>
                </a:highlight>
              </a:rPr>
              <a:t>≥10 mm unlikely</a:t>
            </a:r>
            <a:r>
              <a:rPr lang="en" dirty="0">
                <a:solidFill>
                  <a:srgbClr val="666666"/>
                </a:solidFill>
                <a:highlight>
                  <a:srgbClr val="FFFFFF"/>
                </a:highlight>
              </a:rPr>
              <a:t> to pass spontaneously</a:t>
            </a:r>
            <a:endParaRPr dirty="0">
              <a:solidFill>
                <a:srgbClr val="666666"/>
              </a:solidFill>
              <a:highlight>
                <a:srgbClr val="FFFFFF"/>
              </a:highlight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b="1" dirty="0"/>
              <a:t>Stone location</a:t>
            </a:r>
            <a:r>
              <a:rPr lang="en" dirty="0"/>
              <a:t> also important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Proximal stones less likely to pass spontaneously than distal stones</a:t>
            </a: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 dirty="0"/>
              <a:t>Facilitating Stone Passage </a:t>
            </a:r>
            <a:endParaRPr b="1"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Tamsulosin 0.4 mg daily for stones &gt;5mm and </a:t>
            </a:r>
            <a:r>
              <a:rPr lang="en" dirty="0">
                <a:solidFill>
                  <a:srgbClr val="666666"/>
                </a:solidFill>
                <a:highlight>
                  <a:srgbClr val="FFFFFF"/>
                </a:highlight>
              </a:rPr>
              <a:t>≤10mm</a:t>
            </a:r>
            <a:endParaRPr dirty="0">
              <a:solidFill>
                <a:srgbClr val="666666"/>
              </a:solidFill>
              <a:highlight>
                <a:srgbClr val="FFFFFF"/>
              </a:highlight>
            </a:endParaRPr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>
                <a:solidFill>
                  <a:srgbClr val="666666"/>
                </a:solidFill>
                <a:highlight>
                  <a:srgbClr val="FFFFFF"/>
                </a:highlight>
              </a:rPr>
              <a:t>Smaller effect size versus placebo with smaller stones &lt;5mm</a:t>
            </a:r>
            <a:r>
              <a:rPr lang="en" baseline="30000" dirty="0">
                <a:solidFill>
                  <a:srgbClr val="666666"/>
                </a:solidFill>
                <a:highlight>
                  <a:srgbClr val="FFFFFF"/>
                </a:highlight>
              </a:rPr>
              <a:t>12</a:t>
            </a:r>
            <a:endParaRPr baseline="30000" dirty="0">
              <a:solidFill>
                <a:srgbClr val="666666"/>
              </a:solidFill>
              <a:highlight>
                <a:srgbClr val="FFFFFF"/>
              </a:highlight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rgbClr val="666666"/>
              </a:buClr>
              <a:buSzPts val="1800"/>
              <a:buChar char="●"/>
            </a:pPr>
            <a:r>
              <a:rPr lang="en" dirty="0">
                <a:solidFill>
                  <a:srgbClr val="666666"/>
                </a:solidFill>
                <a:highlight>
                  <a:srgbClr val="FFFFFF"/>
                </a:highlight>
              </a:rPr>
              <a:t>Nifedipine is an alternative, but data suggests faster passage with tamsulosin</a:t>
            </a:r>
            <a:r>
              <a:rPr lang="en" baseline="30000" dirty="0">
                <a:solidFill>
                  <a:srgbClr val="666666"/>
                </a:solidFill>
                <a:highlight>
                  <a:srgbClr val="FFFFFF"/>
                </a:highlight>
              </a:rPr>
              <a:t>13</a:t>
            </a:r>
            <a:endParaRPr baseline="30000" dirty="0">
              <a:solidFill>
                <a:srgbClr val="666666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35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anagement</a:t>
            </a:r>
            <a:endParaRPr/>
          </a:p>
        </p:txBody>
      </p:sp>
      <p:sp>
        <p:nvSpPr>
          <p:cNvPr id="193" name="Google Shape;193;p35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Urologic Consultation for Urgent Intervention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Urosepsi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cute Kidney Injury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nuria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Intractable pain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Intractable nausea/vomit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High grade obstruction of a solitary or transplanted kidney</a:t>
            </a:r>
            <a:endParaRPr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Google Shape;198;p3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sposition</a:t>
            </a:r>
            <a:endParaRPr/>
          </a:p>
        </p:txBody>
      </p:sp>
      <p:sp>
        <p:nvSpPr>
          <p:cNvPr id="199" name="Google Shape;199;p3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Home if: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Resolution of pain, nausea, vomit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Stone passage</a:t>
            </a:r>
            <a:endParaRPr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b="1"/>
              <a:t>Admit if: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Urosepsis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Worsening renal function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Intractable pain, nausea, vomit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ny indication for urgent decompression</a:t>
            </a:r>
            <a:endParaRPr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37"/>
          <p:cNvSpPr txBox="1">
            <a:spLocks noGrp="1"/>
          </p:cNvSpPr>
          <p:nvPr>
            <p:ph type="title"/>
          </p:nvPr>
        </p:nvSpPr>
        <p:spPr>
          <a:xfrm>
            <a:off x="311700" y="2164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References</a:t>
            </a:r>
            <a:endParaRPr dirty="0"/>
          </a:p>
        </p:txBody>
      </p:sp>
      <p:sp>
        <p:nvSpPr>
          <p:cNvPr id="205" name="Google Shape;205;p37"/>
          <p:cNvSpPr txBox="1">
            <a:spLocks noGrp="1"/>
          </p:cNvSpPr>
          <p:nvPr>
            <p:ph type="body" idx="1"/>
          </p:nvPr>
        </p:nvSpPr>
        <p:spPr>
          <a:xfrm>
            <a:off x="623400" y="633209"/>
            <a:ext cx="8520600" cy="437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solidFill>
                  <a:schemeClr val="bg1"/>
                </a:solidFill>
              </a:rPr>
              <a:t>Curhan GC, Aronson MD, Preminger G</a:t>
            </a:r>
            <a:r>
              <a:rPr lang="en-US" sz="900" dirty="0">
                <a:solidFill>
                  <a:schemeClr val="bg1"/>
                </a:solidFill>
              </a:rPr>
              <a:t>m</a:t>
            </a:r>
            <a:r>
              <a:rPr lang="en" sz="900" dirty="0">
                <a:solidFill>
                  <a:schemeClr val="bg1"/>
                </a:solidFill>
              </a:rPr>
              <a:t>. </a:t>
            </a:r>
            <a:r>
              <a:rPr lang="en-US" sz="900" dirty="0">
                <a:solidFill>
                  <a:schemeClr val="bg1"/>
                </a:solidFill>
              </a:rPr>
              <a:t> </a:t>
            </a:r>
            <a:r>
              <a:rPr lang="en" sz="900" dirty="0">
                <a:solidFill>
                  <a:schemeClr val="bg1"/>
                </a:solidFill>
              </a:rPr>
              <a:t>Diagnosis and acute management of suspected nephrolithiasis in adults. UpToDate.com. Updated July 2, 2019.</a:t>
            </a:r>
            <a:r>
              <a:rPr lang="en" sz="900" dirty="0">
                <a:solidFill>
                  <a:schemeClr val="bg1"/>
                </a:solidFill>
                <a:ea typeface="+mn-lt"/>
                <a:cs typeface="+mn-lt"/>
              </a:rPr>
              <a:t>Accessed on January 27, 2020</a:t>
            </a:r>
            <a:r>
              <a:rPr lang="en" sz="900" dirty="0">
                <a:solidFill>
                  <a:schemeClr val="bg1"/>
                </a:solidFill>
              </a:rPr>
              <a:t>. Available at:</a:t>
            </a:r>
            <a:r>
              <a:rPr lang="en" sz="900" u="sng" dirty="0">
                <a:solidFill>
                  <a:schemeClr val="bg1"/>
                </a:solidFill>
              </a:rPr>
              <a:t> </a:t>
            </a:r>
            <a:r>
              <a:rPr lang="en" sz="900" dirty="0">
                <a:ea typeface="+mn-lt"/>
                <a:cs typeface="+mn-lt"/>
                <a:hlinkClick r:id="rId3"/>
              </a:rPr>
              <a:t>https://www.uptodate.com/contents/diagnosis-and-acute-management-of-suspected-nephrolithiasis-in-adults</a:t>
            </a:r>
            <a:endParaRPr lang="en"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Niemann T, Kollmann T, Bongartz G. Diagnostic performance of low-dose CT for the detection of urolithiasis: a meta-analysis. </a:t>
            </a:r>
            <a:r>
              <a:rPr lang="en" sz="900" i="1" dirty="0">
                <a:ea typeface="+mn-lt"/>
                <a:cs typeface="+mn-lt"/>
              </a:rPr>
              <a:t>AJR Am J </a:t>
            </a:r>
            <a:r>
              <a:rPr lang="en" sz="900" i="1" dirty="0" err="1">
                <a:ea typeface="+mn-lt"/>
                <a:cs typeface="+mn-lt"/>
              </a:rPr>
              <a:t>Roentgenol</a:t>
            </a:r>
            <a:r>
              <a:rPr lang="en" sz="900" dirty="0">
                <a:ea typeface="+mn-lt"/>
                <a:cs typeface="+mn-lt"/>
              </a:rPr>
              <a:t>. 2008;191(2):396-401.</a:t>
            </a:r>
            <a:endParaRPr lang="en"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Fowler KA, Locken JA, Duchesne JH, Williamson MR. US for detecting renal calculi with nonenhanced CT as a reference standard. </a:t>
            </a:r>
            <a:r>
              <a:rPr lang="en" sz="900" i="1" dirty="0">
                <a:ea typeface="+mn-lt"/>
                <a:cs typeface="+mn-lt"/>
              </a:rPr>
              <a:t>Radiology</a:t>
            </a:r>
            <a:r>
              <a:rPr lang="en" sz="900" dirty="0">
                <a:ea typeface="+mn-lt"/>
                <a:cs typeface="+mn-lt"/>
              </a:rPr>
              <a:t>. 2002;222(1):109-113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 err="1">
                <a:ea typeface="+mn-lt"/>
                <a:cs typeface="+mn-lt"/>
              </a:rPr>
              <a:t>Ulusan</a:t>
            </a:r>
            <a:r>
              <a:rPr lang="en" sz="900" dirty="0">
                <a:ea typeface="+mn-lt"/>
                <a:cs typeface="+mn-lt"/>
              </a:rPr>
              <a:t> S, Koc Z, Tokmak N. Accuracy of sonography for detecting renal stone: comparison with CT. </a:t>
            </a:r>
            <a:r>
              <a:rPr lang="en" sz="900" i="1" dirty="0">
                <a:ea typeface="+mn-lt"/>
                <a:cs typeface="+mn-lt"/>
              </a:rPr>
              <a:t>J Clin Ultrasound</a:t>
            </a:r>
            <a:r>
              <a:rPr lang="en" sz="900" dirty="0">
                <a:ea typeface="+mn-lt"/>
                <a:cs typeface="+mn-lt"/>
              </a:rPr>
              <a:t>. 2007;35(5):256-261. </a:t>
            </a:r>
            <a:endParaRPr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Jung SI, Kim YJ, Park HS, et al. Sensitivity of digital abdominal radiography for the detection of ureter stones by stone size and location. </a:t>
            </a:r>
            <a:r>
              <a:rPr lang="en" sz="900" i="1" dirty="0">
                <a:ea typeface="+mn-lt"/>
                <a:cs typeface="+mn-lt"/>
              </a:rPr>
              <a:t>J </a:t>
            </a:r>
            <a:r>
              <a:rPr lang="en" sz="900" i="1" dirty="0" err="1">
                <a:ea typeface="+mn-lt"/>
                <a:cs typeface="+mn-lt"/>
              </a:rPr>
              <a:t>Comput</a:t>
            </a:r>
            <a:r>
              <a:rPr lang="en" sz="900" i="1" dirty="0">
                <a:ea typeface="+mn-lt"/>
                <a:cs typeface="+mn-lt"/>
              </a:rPr>
              <a:t> Assist </a:t>
            </a:r>
            <a:r>
              <a:rPr lang="en" sz="900" i="1" dirty="0" err="1">
                <a:ea typeface="+mn-lt"/>
                <a:cs typeface="+mn-lt"/>
              </a:rPr>
              <a:t>Tomogr</a:t>
            </a:r>
            <a:r>
              <a:rPr lang="en" sz="900" dirty="0">
                <a:ea typeface="+mn-lt"/>
                <a:cs typeface="+mn-lt"/>
              </a:rPr>
              <a:t>. 2010;34(6):879-882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Levine JA, </a:t>
            </a:r>
            <a:r>
              <a:rPr lang="en" sz="900" dirty="0" err="1">
                <a:ea typeface="+mn-lt"/>
                <a:cs typeface="+mn-lt"/>
              </a:rPr>
              <a:t>Neitlich</a:t>
            </a:r>
            <a:r>
              <a:rPr lang="en" sz="900" dirty="0">
                <a:ea typeface="+mn-lt"/>
                <a:cs typeface="+mn-lt"/>
              </a:rPr>
              <a:t> J, Verga M, Dalrymple N, Smith RC. Ureteral calculi in patients with flank pain: correlation of plain radiography with unenhanced helical CT. </a:t>
            </a:r>
            <a:r>
              <a:rPr lang="en" sz="900" i="1" dirty="0">
                <a:ea typeface="+mn-lt"/>
                <a:cs typeface="+mn-lt"/>
              </a:rPr>
              <a:t>Radiology</a:t>
            </a:r>
            <a:r>
              <a:rPr lang="en" sz="900" dirty="0">
                <a:ea typeface="+mn-lt"/>
                <a:cs typeface="+mn-lt"/>
              </a:rPr>
              <a:t>. 1997;204(1):27-31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Font typeface="Verdana"/>
              <a:buAutoNum type="arabicPeriod"/>
            </a:pPr>
            <a:r>
              <a:rPr lang="en" sz="900" dirty="0">
                <a:ea typeface="+mn-lt"/>
                <a:cs typeface="+mn-lt"/>
              </a:rPr>
              <a:t>Cole RS, Fry CH, Shuttleworth KE. The action of the prostaglandins on isolated human ureteric smooth muscle. </a:t>
            </a:r>
            <a:r>
              <a:rPr lang="en" sz="900" i="1" dirty="0">
                <a:ea typeface="+mn-lt"/>
                <a:cs typeface="+mn-lt"/>
              </a:rPr>
              <a:t>Br J Urol</a:t>
            </a:r>
            <a:r>
              <a:rPr lang="en" sz="900" dirty="0">
                <a:ea typeface="+mn-lt"/>
                <a:cs typeface="+mn-lt"/>
              </a:rPr>
              <a:t>. 1988;61(1):19-26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Holdgate A, Pollock T. Systematic review of the relative efficacy of non-steroidal anti-inflammatory drugs and opioids in the treatment of acute renal colic. </a:t>
            </a:r>
            <a:r>
              <a:rPr lang="en" sz="900" i="1" dirty="0">
                <a:ea typeface="+mn-lt"/>
                <a:cs typeface="+mn-lt"/>
              </a:rPr>
              <a:t>BMJ</a:t>
            </a:r>
            <a:r>
              <a:rPr lang="en" sz="900" dirty="0">
                <a:ea typeface="+mn-lt"/>
                <a:cs typeface="+mn-lt"/>
              </a:rPr>
              <a:t>. 2004 Jun 12;328(7453):1401. </a:t>
            </a:r>
            <a:r>
              <a:rPr lang="en" sz="900" dirty="0" err="1">
                <a:ea typeface="+mn-lt"/>
                <a:cs typeface="+mn-lt"/>
              </a:rPr>
              <a:t>doi</a:t>
            </a:r>
            <a:r>
              <a:rPr lang="en" sz="900" dirty="0">
                <a:ea typeface="+mn-lt"/>
                <a:cs typeface="+mn-lt"/>
              </a:rPr>
              <a:t>: 10.1136/bmj.38119.581991.55. </a:t>
            </a:r>
            <a:r>
              <a:rPr lang="en" sz="900" dirty="0" err="1">
                <a:ea typeface="+mn-lt"/>
                <a:cs typeface="+mn-lt"/>
              </a:rPr>
              <a:t>Epub</a:t>
            </a:r>
            <a:r>
              <a:rPr lang="en" sz="900" dirty="0">
                <a:ea typeface="+mn-lt"/>
                <a:cs typeface="+mn-lt"/>
              </a:rPr>
              <a:t> 2004 Jun 3. Erratum in: BMJ. 2004 Oct 30;329(7473):1019. </a:t>
            </a:r>
            <a:r>
              <a:rPr lang="en-US" sz="900" dirty="0">
                <a:ea typeface="+mn-lt"/>
                <a:cs typeface="+mn-lt"/>
              </a:rPr>
              <a:t>PMID: 15178585; PMCID: PMC421776.</a:t>
            </a: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-US" sz="900" dirty="0">
                <a:ea typeface="+mn-lt"/>
                <a:cs typeface="+mn-lt"/>
              </a:rPr>
              <a:t>Safdar B, </a:t>
            </a:r>
            <a:r>
              <a:rPr lang="en-US" sz="900" dirty="0" err="1">
                <a:ea typeface="+mn-lt"/>
                <a:cs typeface="+mn-lt"/>
              </a:rPr>
              <a:t>Degutis</a:t>
            </a:r>
            <a:r>
              <a:rPr lang="en-US" sz="900" dirty="0">
                <a:ea typeface="+mn-lt"/>
                <a:cs typeface="+mn-lt"/>
              </a:rPr>
              <a:t> LC, Landry K, </a:t>
            </a:r>
            <a:r>
              <a:rPr lang="en-US" sz="900" dirty="0" err="1">
                <a:ea typeface="+mn-lt"/>
                <a:cs typeface="+mn-lt"/>
              </a:rPr>
              <a:t>Vedere</a:t>
            </a:r>
            <a:r>
              <a:rPr lang="en-US" sz="900" dirty="0">
                <a:ea typeface="+mn-lt"/>
                <a:cs typeface="+mn-lt"/>
              </a:rPr>
              <a:t> SR, </a:t>
            </a:r>
            <a:r>
              <a:rPr lang="en-US" sz="900" dirty="0" err="1">
                <a:ea typeface="+mn-lt"/>
                <a:cs typeface="+mn-lt"/>
              </a:rPr>
              <a:t>Moscovitz</a:t>
            </a:r>
            <a:r>
              <a:rPr lang="en-US" sz="900" dirty="0">
                <a:ea typeface="+mn-lt"/>
                <a:cs typeface="+mn-lt"/>
              </a:rPr>
              <a:t> HC, D'Onofrio G. Intravenous morphine plus ketorolac is superior to either drug alone for treatment of acute renal colic. </a:t>
            </a:r>
            <a:r>
              <a:rPr lang="en-US" sz="900" i="1" dirty="0">
                <a:ea typeface="+mn-lt"/>
                <a:cs typeface="+mn-lt"/>
              </a:rPr>
              <a:t>Ann Emerg Med</a:t>
            </a:r>
            <a:r>
              <a:rPr lang="en-US" sz="900" dirty="0">
                <a:ea typeface="+mn-lt"/>
                <a:cs typeface="+mn-lt"/>
              </a:rPr>
              <a:t>. 2006;48(2):173-181.e1. doi:10.1016/j.annemergmed.2006.03.013</a:t>
            </a:r>
            <a:endParaRPr lang="en-US"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Springhart WP, Marguet CG, Sur RL, et al. Forced versus minimal intravenous hydration in the management of acute renal colic: a randomized trial. </a:t>
            </a:r>
            <a:r>
              <a:rPr lang="en" sz="900" i="1" dirty="0">
                <a:ea typeface="+mn-lt"/>
                <a:cs typeface="+mn-lt"/>
              </a:rPr>
              <a:t>J </a:t>
            </a:r>
            <a:r>
              <a:rPr lang="en" sz="900" i="1" dirty="0" err="1">
                <a:ea typeface="+mn-lt"/>
                <a:cs typeface="+mn-lt"/>
              </a:rPr>
              <a:t>Endourol</a:t>
            </a:r>
            <a:r>
              <a:rPr lang="en" sz="900" dirty="0">
                <a:ea typeface="+mn-lt"/>
                <a:cs typeface="+mn-lt"/>
              </a:rPr>
              <a:t>. 2006;20(10):713-716.</a:t>
            </a:r>
            <a:endParaRPr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Coll DM, Varanelli MJ, Smith RC. Relationship of spontaneous passage of ureteral calculi to stone size and location as revealed by unenhanced helical CT. </a:t>
            </a:r>
            <a:r>
              <a:rPr lang="en" sz="900" i="1" dirty="0">
                <a:ea typeface="+mn-lt"/>
                <a:cs typeface="+mn-lt"/>
              </a:rPr>
              <a:t>AJR Am J </a:t>
            </a:r>
            <a:r>
              <a:rPr lang="en" sz="900" i="1" dirty="0" err="1">
                <a:ea typeface="+mn-lt"/>
                <a:cs typeface="+mn-lt"/>
              </a:rPr>
              <a:t>Roentgenol</a:t>
            </a:r>
            <a:r>
              <a:rPr lang="en" sz="900" dirty="0">
                <a:ea typeface="+mn-lt"/>
                <a:cs typeface="+mn-lt"/>
              </a:rPr>
              <a:t>. 2002;178(1):101-103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 err="1">
                <a:ea typeface="+mn-lt"/>
                <a:cs typeface="+mn-lt"/>
              </a:rPr>
              <a:t>Campschroer</a:t>
            </a:r>
            <a:r>
              <a:rPr lang="en" sz="900" dirty="0">
                <a:ea typeface="+mn-lt"/>
                <a:cs typeface="+mn-lt"/>
              </a:rPr>
              <a:t> T, Zhu X, </a:t>
            </a:r>
            <a:r>
              <a:rPr lang="en" sz="900" dirty="0" err="1">
                <a:ea typeface="+mn-lt"/>
                <a:cs typeface="+mn-lt"/>
              </a:rPr>
              <a:t>Vernooij</a:t>
            </a:r>
            <a:r>
              <a:rPr lang="en" sz="900" dirty="0">
                <a:ea typeface="+mn-lt"/>
                <a:cs typeface="+mn-lt"/>
              </a:rPr>
              <a:t> RW, Lock MT. Alpha-blockers as medical expulsive therapy for ureteral stones. </a:t>
            </a:r>
            <a:r>
              <a:rPr lang="en" sz="900" i="1" dirty="0">
                <a:ea typeface="+mn-lt"/>
                <a:cs typeface="+mn-lt"/>
              </a:rPr>
              <a:t>Cochrane Database Syst Rev</a:t>
            </a:r>
            <a:r>
              <a:rPr lang="en" sz="900" dirty="0">
                <a:ea typeface="+mn-lt"/>
                <a:cs typeface="+mn-lt"/>
              </a:rPr>
              <a:t>. 2018;4(4):CD008509. Published 2018 Apr 5. doi:10.1002/14651858.CD008509.pub3</a:t>
            </a:r>
            <a:endParaRPr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Porpiglia F, </a:t>
            </a:r>
            <a:r>
              <a:rPr lang="en" sz="900" dirty="0" err="1">
                <a:ea typeface="+mn-lt"/>
                <a:cs typeface="+mn-lt"/>
              </a:rPr>
              <a:t>Ghignone</a:t>
            </a:r>
            <a:r>
              <a:rPr lang="en" sz="900" dirty="0">
                <a:ea typeface="+mn-lt"/>
                <a:cs typeface="+mn-lt"/>
              </a:rPr>
              <a:t> G, Fiori C, Fontana D, Scarpa RM. Nifedipine versus tamsulosin for the management of lower ureteral stones. </a:t>
            </a:r>
            <a:r>
              <a:rPr lang="en" sz="900" i="1" dirty="0">
                <a:ea typeface="+mn-lt"/>
                <a:cs typeface="+mn-lt"/>
              </a:rPr>
              <a:t>J Urol</a:t>
            </a:r>
            <a:r>
              <a:rPr lang="en" sz="900" dirty="0">
                <a:ea typeface="+mn-lt"/>
                <a:cs typeface="+mn-lt"/>
              </a:rPr>
              <a:t>. 2004;172(2):568-571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ea typeface="+mn-lt"/>
                <a:cs typeface="+mn-lt"/>
              </a:rPr>
              <a:t>Teichman JM. Clinical practice. Acute renal colic from ureteral calculus. </a:t>
            </a:r>
            <a:r>
              <a:rPr lang="en" sz="900" i="1" dirty="0">
                <a:ea typeface="+mn-lt"/>
                <a:cs typeface="+mn-lt"/>
              </a:rPr>
              <a:t>N Engl J Med</a:t>
            </a:r>
            <a:r>
              <a:rPr lang="en" sz="900" dirty="0">
                <a:ea typeface="+mn-lt"/>
                <a:cs typeface="+mn-lt"/>
              </a:rPr>
              <a:t>. 2004;350(7):684-693.</a:t>
            </a:r>
            <a:endParaRPr sz="900" dirty="0">
              <a:ea typeface="+mn-lt"/>
              <a:cs typeface="+mn-lt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>
                <a:solidFill>
                  <a:schemeClr val="bg1"/>
                </a:solidFill>
              </a:rPr>
              <a:t>Baba Y, Bickle I, et al. Ureteric Calculi. Radiopaedia.com Accessed March 11, 2021. Available at: </a:t>
            </a:r>
            <a:r>
              <a:rPr lang="en" sz="900" dirty="0">
                <a:solidFill>
                  <a:schemeClr val="bg1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radiopaedia.org/articles/ureteric-calculi?lang=us</a:t>
            </a:r>
            <a:endParaRPr sz="900" dirty="0">
              <a:solidFill>
                <a:schemeClr val="bg1"/>
              </a:solidFill>
              <a:cs typeface="Arial"/>
            </a:endParaRPr>
          </a:p>
          <a:p>
            <a:pPr indent="-288925">
              <a:lnSpc>
                <a:spcPct val="100000"/>
              </a:lnSpc>
              <a:buClr>
                <a:srgbClr val="666666"/>
              </a:buClr>
              <a:buSzPts val="950"/>
              <a:buAutoNum type="arabicPeriod"/>
            </a:pPr>
            <a:r>
              <a:rPr lang="en" sz="900" dirty="0" err="1">
                <a:ea typeface="+mn-lt"/>
                <a:cs typeface="+mn-lt"/>
              </a:rPr>
              <a:t>Semins</a:t>
            </a:r>
            <a:r>
              <a:rPr lang="en" sz="900" dirty="0">
                <a:ea typeface="+mn-lt"/>
                <a:cs typeface="+mn-lt"/>
              </a:rPr>
              <a:t> MJ, Feng Z, Trock B, Bohlman M, Hosek W, Matlaga BR. Evaluation of acute renal colic: a comparison of non-contrast CT versus 3-T non-contrast HASTE MR urography. </a:t>
            </a:r>
            <a:r>
              <a:rPr lang="en" sz="900" i="1" dirty="0">
                <a:ea typeface="+mn-lt"/>
                <a:cs typeface="+mn-lt"/>
              </a:rPr>
              <a:t>Urolithiasis</a:t>
            </a:r>
            <a:r>
              <a:rPr lang="en" sz="900" dirty="0">
                <a:ea typeface="+mn-lt"/>
                <a:cs typeface="+mn-lt"/>
              </a:rPr>
              <a:t>. 2013;41(1):43-46. </a:t>
            </a:r>
            <a:endParaRPr sz="900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History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cute onset abdominal or flank pain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Nausea / vomit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Urinary urgency / frequency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Difficulty urinat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Penile/testicular or labial pain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Hematuria (can be gross or microscopic)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Imaging Modalities: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-"/>
            </a:pPr>
            <a:r>
              <a:rPr lang="en"/>
              <a:t>Preferred:  </a:t>
            </a:r>
            <a:r>
              <a:rPr lang="en" b="1"/>
              <a:t>Low-dose</a:t>
            </a:r>
            <a:r>
              <a:rPr lang="en"/>
              <a:t> CT Abdomen and Pelvis </a:t>
            </a:r>
            <a:r>
              <a:rPr lang="en" b="1"/>
              <a:t>without </a:t>
            </a:r>
            <a:r>
              <a:rPr lang="en"/>
              <a:t>IV contrast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"/>
              <a:t>Alternative: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-"/>
            </a:pPr>
            <a:r>
              <a:rPr lang="en" b="1"/>
              <a:t>Standard-dose</a:t>
            </a:r>
            <a:r>
              <a:rPr lang="en"/>
              <a:t> CT Abdomen and Pelvis without IV contrast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-"/>
            </a:pPr>
            <a:r>
              <a:rPr lang="en"/>
              <a:t>Renal/Bladder Ultrasound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"/>
              <a:t>Less Frequently Used: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-"/>
            </a:pPr>
            <a:r>
              <a:rPr lang="en"/>
              <a:t>Abdominal X-ray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-"/>
            </a:pPr>
            <a:r>
              <a:rPr lang="en"/>
              <a:t>Intravenous Pyelogram (IVP)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-"/>
            </a:pPr>
            <a:r>
              <a:rPr lang="en"/>
              <a:t>MRI Abdomen and Pelvis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body" idx="1"/>
          </p:nvPr>
        </p:nvSpPr>
        <p:spPr>
          <a:xfrm>
            <a:off x="311700" y="14572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CT A/P without IV contrast</a:t>
            </a:r>
            <a:endParaRPr b="1" baseline="30000"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b="1" dirty="0"/>
              <a:t>Highest diagnostic accuracy (sensitivity 97%, specificity 95%)</a:t>
            </a:r>
            <a:r>
              <a:rPr lang="en" baseline="30000" dirty="0"/>
              <a:t>2</a:t>
            </a:r>
            <a:endParaRPr baseline="300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Reliably detects hydronephrosi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Accurate stone size measurements and ureteral localization for treatment planning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Dis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Ionizing radiation </a:t>
            </a:r>
            <a:r>
              <a:rPr lang="en" b="1" dirty="0"/>
              <a:t>(low-dose 2-3 mSv preferred over standard dose 10-12 mSv)</a:t>
            </a:r>
            <a:endParaRPr b="1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Rarely may require a second set of images after IV contrast needed for definitive diagnosis of urolithiasis to distinguish ureteral stones from phleboliths</a:t>
            </a:r>
            <a:endParaRPr sz="10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8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86" name="Google Shape;86;p18"/>
          <p:cNvSpPr txBox="1">
            <a:spLocks noGrp="1"/>
          </p:cNvSpPr>
          <p:nvPr>
            <p:ph type="body" idx="1"/>
          </p:nvPr>
        </p:nvSpPr>
        <p:spPr>
          <a:xfrm>
            <a:off x="311700" y="14572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CT A/P without IV contrast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Considerations</a:t>
            </a:r>
            <a:r>
              <a:rPr lang="en" baseline="30000"/>
              <a:t>2</a:t>
            </a:r>
            <a:endParaRPr baseline="300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400"/>
              <a:t>If patient is pregnant, ultrasound is preferred</a:t>
            </a:r>
            <a:endParaRPr sz="14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400"/>
              <a:t>If patient has BMI &gt;30, or weighs &gt;130 kg (male) or &gt;115 kg (female), </a:t>
            </a:r>
            <a:r>
              <a:rPr lang="en" sz="1400" b="1"/>
              <a:t>standard dose</a:t>
            </a:r>
            <a:r>
              <a:rPr lang="en" sz="1400"/>
              <a:t> CT is preferred</a:t>
            </a:r>
            <a:endParaRPr sz="14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400"/>
              <a:t>Low dose CT may be less reliable for detected small stones &lt;2mm</a:t>
            </a:r>
            <a:endParaRPr sz="14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400"/>
              <a:t>CT A/P with IV contrast may reduce sensitivity for detecting small stones, but does not affect ability to detect stones &gt;3mm (sensitivity 95%); therefore, if contrast-enhanced CT has already been performed, it is useful in detecting clinically significant stones</a:t>
            </a:r>
            <a:endParaRPr sz="14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sz="1400"/>
              <a:t>Appearance, density and location of a stone on CT may suggest its composition; calcium oxalate calculi can be distinguished from uric acid, cystine, and struvite stones.</a:t>
            </a:r>
            <a:endParaRPr sz="140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19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93" name="Google Shape;93;p19"/>
          <p:cNvSpPr txBox="1">
            <a:spLocks noGrp="1"/>
          </p:cNvSpPr>
          <p:nvPr>
            <p:ph type="body" idx="1"/>
          </p:nvPr>
        </p:nvSpPr>
        <p:spPr>
          <a:xfrm>
            <a:off x="311700" y="13048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Ultrasound Kidneys and Bladder</a:t>
            </a:r>
            <a:endParaRPr b="1" dirty="0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No ionizing radiation</a:t>
            </a:r>
            <a:endParaRPr dirty="0"/>
          </a:p>
          <a:p>
            <a:pPr marL="1371600" lvl="2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■"/>
            </a:pPr>
            <a:r>
              <a:rPr lang="en" dirty="0"/>
              <a:t>Lower cumulative dose in patients undergoing </a:t>
            </a:r>
            <a:r>
              <a:rPr lang="en" b="1" dirty="0"/>
              <a:t>repeated imaging</a:t>
            </a:r>
            <a:r>
              <a:rPr lang="en" dirty="0"/>
              <a:t> in settings where low-dose CT is not available</a:t>
            </a:r>
            <a:endParaRPr dirty="0"/>
          </a:p>
          <a:p>
            <a:pPr marL="1371600" lvl="2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■"/>
            </a:pPr>
            <a:r>
              <a:rPr lang="en" dirty="0"/>
              <a:t>Preferred in pregnant patient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Reliably detects hydronephrosis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 dirty="0"/>
              <a:t>Disadvantages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b="1" dirty="0"/>
              <a:t>Low-moderate sensitivity</a:t>
            </a:r>
            <a:r>
              <a:rPr lang="en" dirty="0"/>
              <a:t> and </a:t>
            </a:r>
            <a:r>
              <a:rPr lang="en" b="1" dirty="0"/>
              <a:t>wide variability</a:t>
            </a:r>
            <a:r>
              <a:rPr lang="en" dirty="0"/>
              <a:t> in diagnostic performance</a:t>
            </a:r>
            <a:endParaRPr dirty="0"/>
          </a:p>
          <a:p>
            <a:pPr marL="1371600" lvl="2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■"/>
            </a:pPr>
            <a:r>
              <a:rPr lang="en" dirty="0"/>
              <a:t>Detects 24-57% of stones seen with CT</a:t>
            </a:r>
            <a:r>
              <a:rPr lang="en" baseline="30000" dirty="0"/>
              <a:t>3,4</a:t>
            </a:r>
            <a:endParaRPr baseline="30000"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Inaccurate stone size measurements and ureteral localization for treatment planning</a:t>
            </a:r>
            <a:endParaRPr dirty="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 dirty="0"/>
              <a:t>Likely nondiagnostic in patients with large body habitus or those with end-stage renal disease (ESRD)</a:t>
            </a:r>
            <a:endParaRPr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20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100" name="Google Shape;100;p20"/>
          <p:cNvSpPr txBox="1">
            <a:spLocks noGrp="1"/>
          </p:cNvSpPr>
          <p:nvPr>
            <p:ph type="body" idx="1"/>
          </p:nvPr>
        </p:nvSpPr>
        <p:spPr>
          <a:xfrm>
            <a:off x="311700" y="1914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Abdominal Radiograph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Accurate stone size measurements and ureteral localization for treatment plann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Dis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Low-moderate sensitivity and wide variability in diagnostic performance</a:t>
            </a:r>
            <a:endParaRPr/>
          </a:p>
          <a:p>
            <a:pPr marL="1371600" lvl="2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■"/>
            </a:pPr>
            <a:r>
              <a:rPr lang="en"/>
              <a:t>Detects 29-59% of stones seen with CT</a:t>
            </a:r>
            <a:r>
              <a:rPr lang="en" baseline="30000"/>
              <a:t>5,6</a:t>
            </a:r>
            <a:endParaRPr baseline="30000"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Can miss radiolucent stones (uric acid) and small stones &lt;5 mm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Does not detect hydronephrosi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Ionizing radiation (</a:t>
            </a:r>
            <a:r>
              <a:rPr lang="en" b="1"/>
              <a:t>effective dose 0.8 mSv</a:t>
            </a:r>
            <a:r>
              <a:rPr lang="en"/>
              <a:t> with each view)</a:t>
            </a:r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2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Diagnosis</a:t>
            </a:r>
            <a:endParaRPr/>
          </a:p>
        </p:txBody>
      </p:sp>
      <p:sp>
        <p:nvSpPr>
          <p:cNvPr id="107" name="Google Shape;107;p21"/>
          <p:cNvSpPr txBox="1">
            <a:spLocks noGrp="1"/>
          </p:cNvSpPr>
          <p:nvPr>
            <p:ph type="body" idx="1"/>
          </p:nvPr>
        </p:nvSpPr>
        <p:spPr>
          <a:xfrm>
            <a:off x="311700" y="20668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Intravenous Pyelogram (IVP)</a:t>
            </a:r>
            <a:endParaRPr b="1"/>
          </a:p>
          <a:p>
            <a:pPr marL="457200" lvl="0" indent="-342900" algn="l" rtl="0">
              <a:spcBef>
                <a:spcPts val="160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Reliably detects hydronephrosi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Accurate stone size measurements and ureteral localization for treatment planning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●"/>
            </a:pPr>
            <a:r>
              <a:rPr lang="en"/>
              <a:t>Disadvantages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Diagnostic performance not quantified, but less accurate than CT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Ionizing radiation (</a:t>
            </a:r>
            <a:r>
              <a:rPr lang="en" b="1"/>
              <a:t>effective dose 12 mSv</a:t>
            </a:r>
            <a:r>
              <a:rPr lang="en"/>
              <a:t>)</a:t>
            </a:r>
            <a:endParaRPr/>
          </a:p>
          <a:p>
            <a:pPr marL="914400" lvl="1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○"/>
            </a:pPr>
            <a:r>
              <a:rPr lang="en"/>
              <a:t>IV contrast required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61</TotalTime>
  <Words>2218</Words>
  <Application>Microsoft Macintosh PowerPoint</Application>
  <PresentationFormat>On-screen Show (16:9)</PresentationFormat>
  <Paragraphs>232</Paragraphs>
  <Slides>25</Slides>
  <Notes>2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9" baseType="lpstr">
      <vt:lpstr>Arial</vt:lpstr>
      <vt:lpstr>Lucida Grande</vt:lpstr>
      <vt:lpstr>Verdana</vt:lpstr>
      <vt:lpstr>NYU Theme</vt:lpstr>
      <vt:lpstr>Nephrolithiasis​</vt:lpstr>
      <vt:lpstr>Objectives</vt:lpstr>
      <vt:lpstr>Diagnosis</vt:lpstr>
      <vt:lpstr>Diagnosis</vt:lpstr>
      <vt:lpstr>Diagnosis</vt:lpstr>
      <vt:lpstr>Diagnosis</vt:lpstr>
      <vt:lpstr>Diagnosis</vt:lpstr>
      <vt:lpstr>Diagnosis</vt:lpstr>
      <vt:lpstr>Diagnosis</vt:lpstr>
      <vt:lpstr>Diagnosis</vt:lpstr>
      <vt:lpstr>Complications of Nephrolithiasis</vt:lpstr>
      <vt:lpstr>Complications of Nephrolithiasis</vt:lpstr>
      <vt:lpstr>Management</vt:lpstr>
      <vt:lpstr>Management</vt:lpstr>
      <vt:lpstr>Management</vt:lpstr>
      <vt:lpstr>Management</vt:lpstr>
      <vt:lpstr>Management</vt:lpstr>
      <vt:lpstr>Management</vt:lpstr>
      <vt:lpstr>Management</vt:lpstr>
      <vt:lpstr>Management</vt:lpstr>
      <vt:lpstr>Management</vt:lpstr>
      <vt:lpstr>Management</vt:lpstr>
      <vt:lpstr>Management</vt:lpstr>
      <vt:lpstr>Disposition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phrolithiasis</dc:title>
  <dc:creator>Klein, Noah</dc:creator>
  <cp:lastModifiedBy>Alisa Wray</cp:lastModifiedBy>
  <cp:revision>62</cp:revision>
  <dcterms:modified xsi:type="dcterms:W3CDTF">2021-04-12T18:31:03Z</dcterms:modified>
</cp:coreProperties>
</file>